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</p:sldIdLst>
  <p:sldSz cx="9144000" cy="6858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151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2D15C-9B94-4281-9B7B-236A059B5181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4010E-A075-4A8E-9215-F130BF6EF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30034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2D15C-9B94-4281-9B7B-236A059B5181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4010E-A075-4A8E-9215-F130BF6EF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68528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2D15C-9B94-4281-9B7B-236A059B5181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4010E-A075-4A8E-9215-F130BF6EF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98838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2D15C-9B94-4281-9B7B-236A059B5181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4010E-A075-4A8E-9215-F130BF6EF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32176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2D15C-9B94-4281-9B7B-236A059B5181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4010E-A075-4A8E-9215-F130BF6EF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52124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2D15C-9B94-4281-9B7B-236A059B5181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4010E-A075-4A8E-9215-F130BF6EF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62899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2D15C-9B94-4281-9B7B-236A059B5181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4010E-A075-4A8E-9215-F130BF6EF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41155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2D15C-9B94-4281-9B7B-236A059B5181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4010E-A075-4A8E-9215-F130BF6EF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8885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2D15C-9B94-4281-9B7B-236A059B5181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4010E-A075-4A8E-9215-F130BF6EF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21662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2D15C-9B94-4281-9B7B-236A059B5181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4010E-A075-4A8E-9215-F130BF6EF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0625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2D15C-9B94-4281-9B7B-236A059B5181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4010E-A075-4A8E-9215-F130BF6EF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15919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12D15C-9B94-4281-9B7B-236A059B5181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24010E-A075-4A8E-9215-F130BF6EF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44069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6BB3C68-A2EA-4F00-8ED0-9C84D227E951}"/>
              </a:ext>
            </a:extLst>
          </p:cNvPr>
          <p:cNvSpPr txBox="1"/>
          <p:nvPr/>
        </p:nvSpPr>
        <p:spPr>
          <a:xfrm>
            <a:off x="797889" y="398099"/>
            <a:ext cx="3180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3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3A8355F5-35E1-4F4C-885D-82DC6FEDAE4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61391" y="705174"/>
            <a:ext cx="4939741" cy="3917166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B2111E7-71D0-4219-A347-DC4891AE3E1B}"/>
              </a:ext>
            </a:extLst>
          </p:cNvPr>
          <p:cNvSpPr txBox="1"/>
          <p:nvPr/>
        </p:nvSpPr>
        <p:spPr>
          <a:xfrm>
            <a:off x="797889" y="4534822"/>
            <a:ext cx="7699248" cy="192507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4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3. PK/PD Analysis of the Relationship Between Maximum Relative Change in Gene Expression and Pelabresib Exposure Metrics.</a:t>
            </a:r>
            <a:r>
              <a:rPr lang="en-US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 inhibitory E</a:t>
            </a:r>
            <a:r>
              <a:rPr lang="en-US" sz="1400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x</a:t>
            </a:r>
            <a:r>
              <a:rPr lang="en-US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odel of drug effect was fit to individual maximum gene suppression (the nadir of individual gene expression versus time profiles) plotted as a continuous function of individual C</a:t>
            </a:r>
            <a:r>
              <a:rPr lang="en-US" sz="1400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x</a:t>
            </a:r>
            <a:r>
              <a:rPr lang="en-US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Panels A and B) and AUC (Panels C and D) for both </a:t>
            </a:r>
            <a:r>
              <a:rPr lang="en-US" sz="14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CR1</a:t>
            </a:r>
            <a:r>
              <a:rPr lang="en-US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Panels B and D) and </a:t>
            </a:r>
            <a:r>
              <a:rPr lang="en-US" sz="14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L8</a:t>
            </a:r>
            <a:r>
              <a:rPr lang="en-US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Panels A and C). Blue circles are observed data, orange dashed curve is the model fit. Model parameters are denoted. AUC=area under the curve; C</a:t>
            </a:r>
            <a:r>
              <a:rPr lang="en-US" sz="1400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x</a:t>
            </a:r>
            <a:r>
              <a:rPr lang="en-US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= maximum plasma concentration; E</a:t>
            </a:r>
            <a:r>
              <a:rPr lang="en-US" sz="1400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x</a:t>
            </a:r>
            <a:r>
              <a:rPr lang="en-US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=inhibitory maximum effect; IC50=inhibitory concentration; PD=pharmacodynamics; PK=pharmacokinetics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068355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</TotalTime>
  <Words>140</Words>
  <Application>Microsoft Office PowerPoint</Application>
  <PresentationFormat>Letter Paper (8.5x11 in)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dy Nichols</dc:creator>
  <cp:lastModifiedBy>Cody Nichols</cp:lastModifiedBy>
  <cp:revision>7</cp:revision>
  <dcterms:created xsi:type="dcterms:W3CDTF">2022-01-07T19:09:15Z</dcterms:created>
  <dcterms:modified xsi:type="dcterms:W3CDTF">2022-05-16T15:14:33Z</dcterms:modified>
</cp:coreProperties>
</file>